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66006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77128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76263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7993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07936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66342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72894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0846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23191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33159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26058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186FC-0E9A-4B7B-97B7-7C45863E372B}" type="datetimeFigureOut">
              <a:rPr lang="hu-HU" smtClean="0"/>
              <a:t>2021.06.17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BB17C-25E9-4936-842D-A8F2ACCB8F1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18962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ábláza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3721677"/>
              </p:ext>
            </p:extLst>
          </p:nvPr>
        </p:nvGraphicFramePr>
        <p:xfrm>
          <a:off x="3049616" y="1111832"/>
          <a:ext cx="5488513" cy="4351343"/>
        </p:xfrm>
        <a:graphic>
          <a:graphicData uri="http://schemas.openxmlformats.org/drawingml/2006/table">
            <a:tbl>
              <a:tblPr/>
              <a:tblGrid>
                <a:gridCol w="1353332">
                  <a:extLst>
                    <a:ext uri="{9D8B030D-6E8A-4147-A177-3AD203B41FA5}">
                      <a16:colId xmlns="" xmlns:a16="http://schemas.microsoft.com/office/drawing/2014/main" val="2267558352"/>
                    </a:ext>
                  </a:extLst>
                </a:gridCol>
                <a:gridCol w="601481">
                  <a:extLst>
                    <a:ext uri="{9D8B030D-6E8A-4147-A177-3AD203B41FA5}">
                      <a16:colId xmlns="" xmlns:a16="http://schemas.microsoft.com/office/drawing/2014/main" val="2409485275"/>
                    </a:ext>
                  </a:extLst>
                </a:gridCol>
                <a:gridCol w="1616480">
                  <a:extLst>
                    <a:ext uri="{9D8B030D-6E8A-4147-A177-3AD203B41FA5}">
                      <a16:colId xmlns="" xmlns:a16="http://schemas.microsoft.com/office/drawing/2014/main" val="3620838595"/>
                    </a:ext>
                  </a:extLst>
                </a:gridCol>
                <a:gridCol w="1917220">
                  <a:extLst>
                    <a:ext uri="{9D8B030D-6E8A-4147-A177-3AD203B41FA5}">
                      <a16:colId xmlns="" xmlns:a16="http://schemas.microsoft.com/office/drawing/2014/main" val="4167856758"/>
                    </a:ext>
                  </a:extLst>
                </a:gridCol>
              </a:tblGrid>
              <a:tr h="20675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9398" marR="9398" marT="9398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igo name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quence 5'-3'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09216016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rB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27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crB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GCTGGTGCTGACTATAT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72003133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crB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AAGGTCCATTGTCTGC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556205616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fnF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6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fnf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CGATGTTATTCCCCTCAA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99726418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fnf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GTTCGTCCTGAGCAT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411823860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gF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6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ofG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GTCTTTCCAGGTCATCC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813828907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ofG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CAGAGTTCGCTTGTTTC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7921926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lJ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6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10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ACGAAGACCAAGATGGC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22759141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L10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TTTCCGCCCTCAAT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24005123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hA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27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rhA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GAGATTGGACAGACTATT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6790819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rhA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TGGACAAGGACAAGACC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07059972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o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6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enolase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TGTAGATGAGGTTGTAGC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673201680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enolase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GAACTCTGGGACGGTAA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704284114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pA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59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g3pd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TGGGTGTGGAGTATGT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878092976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g3pd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ATGGTGATGTCCTCTTC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741030445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pA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59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nsbp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ATATCTTCATCCTGGGTT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67862834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nsbp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GGAGTACTTGCCGTAGTT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41623649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dK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1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pdk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CCTCTTTGCATTGGAA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898324665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pdk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TTTGGTGCTGAAGGTATT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52002935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hC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27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dhC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GAGATGCCAGGACAAAG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46032590"/>
                  </a:ext>
                </a:extLst>
              </a:tr>
              <a:tr h="18796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dhC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GAACCAGTTGATAGCACC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786085715"/>
                  </a:ext>
                </a:extLst>
              </a:tr>
              <a:tr h="1879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rC</a:t>
                      </a:r>
                    </a:p>
                  </a:txBody>
                  <a:tcPr marL="9398" marR="9398" marT="9398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n_35</a:t>
                      </a:r>
                    </a:p>
                  </a:txBody>
                  <a:tcPr marL="9398" marR="9398" marT="939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crC_F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GGGCAAAGGTTATTTC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850382319"/>
                  </a:ext>
                </a:extLst>
              </a:tr>
              <a:tr h="19736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mcrC_R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ATGGGAATGGGTGAAGGAG</a:t>
                      </a:r>
                    </a:p>
                  </a:txBody>
                  <a:tcPr marL="9398" marR="9398" marT="939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6886691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6630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75</Words>
  <Application>Microsoft Office PowerPoint</Application>
  <PresentationFormat>Szélesvásznú</PresentationFormat>
  <Paragraphs>7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Kovács Kornél</dc:creator>
  <cp:lastModifiedBy>Kovács Kornél</cp:lastModifiedBy>
  <cp:revision>5</cp:revision>
  <dcterms:created xsi:type="dcterms:W3CDTF">2021-03-22T15:46:55Z</dcterms:created>
  <dcterms:modified xsi:type="dcterms:W3CDTF">2021-06-17T20:09:16Z</dcterms:modified>
</cp:coreProperties>
</file>